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4"/>
  </p:sldMasterIdLst>
  <p:notesMasterIdLst>
    <p:notesMasterId r:id="rId6"/>
  </p:notesMasterIdLst>
  <p:sldIdLst>
    <p:sldId id="30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9726DD54-61DB-4BEE-8EAF-8D2A0991060F}"/>
    <pc:docChg chg="delSld">
      <pc:chgData name="Anca Pordea (staff)" userId="04217c9e-4602-4538-8d25-5638668eb9f5" providerId="ADAL" clId="{9726DD54-61DB-4BEE-8EAF-8D2A0991060F}" dt="2023-12-18T18:29:19.636" v="1" actId="47"/>
      <pc:docMkLst>
        <pc:docMk/>
      </pc:docMkLst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773720066" sldId="256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406690983" sldId="257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3309942647" sldId="258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56002129" sldId="262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051766301" sldId="263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1729401590" sldId="264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128189669" sldId="265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808561837" sldId="266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005349361" sldId="267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90462980" sldId="268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1479637886" sldId="271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232706692" sldId="277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441496266" sldId="278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672111689" sldId="279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141721781" sldId="280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341255541" sldId="281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272614583" sldId="285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751480510" sldId="288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59477596" sldId="289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090511444" sldId="290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804230355" sldId="293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079981970" sldId="294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567409985" sldId="295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446155509" sldId="297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702511720" sldId="298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4077862176" sldId="299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4281819590" sldId="301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532461093" sldId="302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825408573" sldId="305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567219672" sldId="306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3023848852" sldId="308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165866896" sldId="310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892218898" sldId="311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710938837" sldId="312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3756588774" sldId="314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1331867037" sldId="315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351316601" sldId="316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026450018" sldId="317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1156295227" sldId="318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243933656" sldId="319"/>
        </pc:sldMkLst>
      </pc:sldChg>
      <pc:sldChg chg="del">
        <pc:chgData name="Anca Pordea (staff)" userId="04217c9e-4602-4538-8d25-5638668eb9f5" providerId="ADAL" clId="{9726DD54-61DB-4BEE-8EAF-8D2A0991060F}" dt="2023-12-18T18:29:19.636" v="1" actId="47"/>
        <pc:sldMkLst>
          <pc:docMk/>
          <pc:sldMk cId="2633288119" sldId="320"/>
        </pc:sldMkLst>
      </pc:sldChg>
      <pc:sldChg chg="del">
        <pc:chgData name="Anca Pordea (staff)" userId="04217c9e-4602-4538-8d25-5638668eb9f5" providerId="ADAL" clId="{9726DD54-61DB-4BEE-8EAF-8D2A0991060F}" dt="2023-12-18T18:29:13.436" v="0" actId="47"/>
        <pc:sldMkLst>
          <pc:docMk/>
          <pc:sldMk cId="95252591" sldId="32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 Tabl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features of dominant static tunnels calculated using the Lcp</a:t>
            </a:r>
            <a:r>
              <a:rPr lang="en-GB" sz="18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30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ystal structure in the open state (PDB 5O1L) using the CAVER-</a:t>
            </a:r>
            <a:r>
              <a:rPr lang="en-GB" sz="18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ymol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ugin 3.0.3.</a:t>
            </a:r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644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8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259788C3-39A7-7A2A-B272-96D640B3810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11025989"/>
              </p:ext>
            </p:extLst>
          </p:nvPr>
        </p:nvGraphicFramePr>
        <p:xfrm>
          <a:off x="1693014" y="380010"/>
          <a:ext cx="8805971" cy="3241964"/>
        </p:xfrm>
        <a:graphic>
          <a:graphicData uri="http://schemas.openxmlformats.org/drawingml/2006/table">
            <a:tbl>
              <a:tblPr/>
              <a:tblGrid>
                <a:gridCol w="377416">
                  <a:extLst>
                    <a:ext uri="{9D8B030D-6E8A-4147-A177-3AD203B41FA5}">
                      <a16:colId xmlns:a16="http://schemas.microsoft.com/office/drawing/2014/main" val="2877591139"/>
                    </a:ext>
                  </a:extLst>
                </a:gridCol>
                <a:gridCol w="1585848">
                  <a:extLst>
                    <a:ext uri="{9D8B030D-6E8A-4147-A177-3AD203B41FA5}">
                      <a16:colId xmlns:a16="http://schemas.microsoft.com/office/drawing/2014/main" val="2746576125"/>
                    </a:ext>
                  </a:extLst>
                </a:gridCol>
                <a:gridCol w="2001943">
                  <a:extLst>
                    <a:ext uri="{9D8B030D-6E8A-4147-A177-3AD203B41FA5}">
                      <a16:colId xmlns:a16="http://schemas.microsoft.com/office/drawing/2014/main" val="2954900636"/>
                    </a:ext>
                  </a:extLst>
                </a:gridCol>
                <a:gridCol w="1911692">
                  <a:extLst>
                    <a:ext uri="{9D8B030D-6E8A-4147-A177-3AD203B41FA5}">
                      <a16:colId xmlns:a16="http://schemas.microsoft.com/office/drawing/2014/main" val="2407259387"/>
                    </a:ext>
                  </a:extLst>
                </a:gridCol>
                <a:gridCol w="1452229">
                  <a:extLst>
                    <a:ext uri="{9D8B030D-6E8A-4147-A177-3AD203B41FA5}">
                      <a16:colId xmlns:a16="http://schemas.microsoft.com/office/drawing/2014/main" val="911839857"/>
                    </a:ext>
                  </a:extLst>
                </a:gridCol>
                <a:gridCol w="1476843">
                  <a:extLst>
                    <a:ext uri="{9D8B030D-6E8A-4147-A177-3AD203B41FA5}">
                      <a16:colId xmlns:a16="http://schemas.microsoft.com/office/drawing/2014/main" val="4287880461"/>
                    </a:ext>
                  </a:extLst>
                </a:gridCol>
              </a:tblGrid>
              <a:tr h="1220124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D</a:t>
                      </a:r>
                      <a:r>
                        <a:rPr lang="en-GB" sz="1800" kern="12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verage throughput</a:t>
                      </a:r>
                      <a:r>
                        <a:rPr lang="en-GB" sz="1800" baseline="30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ottleneck 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dius (Å)</a:t>
                      </a:r>
                      <a:r>
                        <a:rPr lang="en-GB" sz="1800" kern="12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verage 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dius (Å)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verage length (Å)</a:t>
                      </a:r>
                      <a:r>
                        <a:rPr lang="en-GB" sz="1800" kern="12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Average curvature</a:t>
                      </a:r>
                      <a:r>
                        <a:rPr lang="en-GB" sz="1800" kern="120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532412"/>
                  </a:ext>
                </a:extLst>
              </a:tr>
              <a:tr h="50546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2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73</a:t>
                      </a:r>
                      <a:endParaRPr lang="en-MY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.43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7388294"/>
                  </a:ext>
                </a:extLst>
              </a:tr>
              <a:tr h="50546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0</a:t>
                      </a:r>
                      <a:endParaRPr lang="en-MY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0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.61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4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252712"/>
                  </a:ext>
                </a:extLst>
              </a:tr>
              <a:tr h="50546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71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.83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5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2307339"/>
                  </a:ext>
                </a:extLst>
              </a:tr>
              <a:tr h="50546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4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4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.66</a:t>
                      </a:r>
                      <a:endParaRPr lang="en-MY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3</a:t>
                      </a:r>
                      <a:endParaRPr lang="en-MY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894821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30C8D81-6303-DE3B-91EE-0F6CE85C5348}"/>
              </a:ext>
            </a:extLst>
          </p:cNvPr>
          <p:cNvSpPr txBox="1"/>
          <p:nvPr/>
        </p:nvSpPr>
        <p:spPr>
          <a:xfrm>
            <a:off x="1576450" y="3712587"/>
            <a:ext cx="9146968" cy="2256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anking of a given cluster based on the throughput; 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bability that the pathway is used as a route for transport of the substances (throughput = e-cost, where cost is calculated by the sum of the cost of the tunnel's Voronoi edges); 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narrowest part of the tunnel; 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ngth of the tunnel from the starting point to the protein surface; 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ape of the tunnel as the ratio between the length of the tunnel and the shortest possible distance between the starting point and the tunnel ending point.</a:t>
            </a:r>
            <a:endParaRPr lang="en-MY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MY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132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Props1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27C83A0-C684-49DF-9D04-84690D7614D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51E6D35-0F9E-4706-8136-70C0AE8BFB49}">
  <ds:schemaRefs>
    <ds:schemaRef ds:uri="786e620f-b1da-4f59-878c-ef7546d25bf1"/>
    <ds:schemaRef ds:uri="http://purl.org/dc/terms/"/>
    <ds:schemaRef ds:uri="http://schemas.microsoft.com/office/2006/documentManagement/types"/>
    <ds:schemaRef ds:uri="http://www.w3.org/XML/1998/namespace"/>
    <ds:schemaRef ds:uri="http://purl.org/dc/dcmitype/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0c1e910d-4918-42f1-af2c-ed1101d63abc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397</TotalTime>
  <Words>177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5</cp:revision>
  <dcterms:created xsi:type="dcterms:W3CDTF">2022-09-23T18:06:25Z</dcterms:created>
  <dcterms:modified xsi:type="dcterms:W3CDTF">2023-12-18T18:29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